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C2C1D9-0025-459F-8CC2-BFE8E7B8D9B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E48A6F-88CF-441E-9E6D-1A15516D99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C3D60C-27B5-4879-80D2-0F819C38B64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366E12-E0DB-456A-9BC0-61FD4E788D5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81E0F7-1DC2-491A-BF21-7E2273BD25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535B20-1416-46B6-A562-DA0ADBEBF8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1AA74C-7DDC-48B1-AE7A-78CB3FE603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AFBE6E-061D-42B3-9A05-2C7C4CEF33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FA095A-6B5B-4316-82CF-59F429C380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93D31B-D4BA-495F-B8BA-96C3A68E11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A4DFBC-508D-49FE-B04D-88F4DD4521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D2E193-E594-4C57-AB40-7F5D76783D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CA9DAD-3CDA-4A14-AA24-08CC32F82D9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16360" y="6249960"/>
            <a:ext cx="906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dditional data file #2: Venn CDK 4 resistant and nonluminal markers in breast cancer cell li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1895400" y="1371600"/>
            <a:ext cx="535320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21T02:58:59Z</dcterms:created>
  <dc:creator>yvenegas</dc:creator>
  <dc:description/>
  <dc:language>en-US</dc:language>
  <cp:lastModifiedBy>yvenegas</cp:lastModifiedBy>
  <dcterms:modified xsi:type="dcterms:W3CDTF">2009-10-22T07:27:58Z</dcterms:modified>
  <cp:revision>4</cp:revision>
  <dc:subject/>
  <dc:title>Slide 1</dc:title>
</cp:coreProperties>
</file>